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117F34-EDE8-4590-9A06-3034088EAD6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8B92EB-C6B6-45C1-9AA0-664FAA150A5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2E3974-D7B3-4652-9285-24180DCB099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23A70B-2E8C-4F14-8175-7908079B586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CECCE4-C15C-497E-83F2-469F04EAE33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5090D3-D5A9-4281-999F-35F4B43262C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4276D6-CDA8-400C-89BF-8E5FB9FA069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476359-1A61-4DD3-B466-19C1499DA17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0F1707-513B-4FDD-8604-A7FE0EB12F6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737B35-8E5E-4AB7-A474-B6AFEE4CB6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B8C54E-CBB6-4035-9BEA-D1FA87E76B8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D8BFF4-84E3-412E-BC09-8B4EE1E1D54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1EA00E8-DFF9-45C5-91A0-54A86D49A3C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131760" y="380880"/>
            <a:ext cx="6649920" cy="664056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609480" y="7267320"/>
            <a:ext cx="5943600" cy="11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igure S2.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Reproducibility of expression microarrays. Dye intensities (log 2) from the technical replicate experiments (0 hrs untreated, 3, 6, 12 hrs TGF-β1-treated) are plotted as scatter plots. Expression data for 150 significant genes are indicated by red dots. The overall correlation coefficient of each plot is also shown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7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6-19T14:31:36Z</dcterms:created>
  <dc:creator>Huaxia Qin</dc:creator>
  <dc:description/>
  <dc:language>en-US</dc:language>
  <cp:lastModifiedBy>Ramana Davuluri</cp:lastModifiedBy>
  <dcterms:modified xsi:type="dcterms:W3CDTF">2008-12-10T15:56:13Z</dcterms:modified>
  <cp:revision>30</cp:revision>
  <dc:subject/>
  <dc:title>Slide 1</dc:title>
</cp:coreProperties>
</file>